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79" r:id="rId2"/>
    <p:sldId id="262" r:id="rId3"/>
    <p:sldId id="263" r:id="rId4"/>
    <p:sldId id="264" r:id="rId5"/>
    <p:sldId id="266" r:id="rId6"/>
    <p:sldId id="265" r:id="rId7"/>
    <p:sldId id="280" r:id="rId8"/>
    <p:sldId id="258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66"/>
    <p:restoredTop sz="94694"/>
  </p:normalViewPr>
  <p:slideViewPr>
    <p:cSldViewPr snapToGrid="0" snapToObjects="1">
      <p:cViewPr>
        <p:scale>
          <a:sx n="54" d="100"/>
          <a:sy n="54" d="100"/>
        </p:scale>
        <p:origin x="720" y="2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AF7FAF-BB3B-D347-9800-13B9B88DAFA0}" type="datetimeFigureOut">
              <a:rPr lang="en-US" smtClean="0"/>
              <a:t>6/5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E1104D-A5AD-2348-BD6D-C773D1D13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351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1702F4-027D-2F41-9FD9-82F2233828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3FF53C-0E01-264D-9BA2-E7B4862055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CAA83D-0C84-DB48-B63A-CBC6D86AA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9B2117-F08D-2D46-86AA-8AC127401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34BBA-1435-9B4C-A1B2-8720EEBF5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658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1432A0-01B9-6B46-8D94-7A251BC6E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BDE86C-439C-E847-8603-9807E7B545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643ECF-3E52-3047-8545-E92915179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041BB-DB27-FD46-A1C2-B24D80345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94369B-E100-E44F-8CC5-F2538CB67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73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9EF167-8E5F-C946-B0D8-58D381C1B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90201C-8278-054D-9BDC-158BC9981A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7D6CA8-4FE1-094C-9942-A5595B741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21D4B-9620-E647-99DD-7C25ADADA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1DEE4-E0D0-7346-981F-ECC76962D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513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276C53-F1AA-FA42-85B3-E2E3E2CD9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5BB3F1-D9B2-ED44-BAD9-C176DA7B8D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64F0B-A476-814D-9DA5-413864D06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C7763-BE8B-154D-90A2-D931B4F0B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C89147-6C06-CE49-AB18-42F5EFEB3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877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8C0D6D-95A9-FF46-95E1-39B2959CF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CE0D1F-3934-5B4A-A554-E0BAE1C369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AE95F4-257C-7C44-BB12-29BA0CCE9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1D0E3C-A668-EB4B-8D15-262B4BAF7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01FCE-05C9-AB49-BCAA-0DF984325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592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A2766F-F046-4A42-8CC6-9CA6C54A8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2A90F6-4AB0-1341-B84F-118E651D5F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43D503-D5EF-504C-9B8F-83C00F1131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A714D2-6C7C-5F4D-B5B2-830A7C28B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74EA65-5086-6E4F-BFF5-1F5DD7F19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6FCB3B-62E0-6847-BA79-F7501476A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122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46567-131C-A247-A97D-1F3DE1704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FF9585-0D60-554E-BA81-C15A406F4D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7E9155-8AB0-9B45-85B5-DF3AEE9AEC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03EE9F-BE30-3F45-8D5D-2D48EC4621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C623687-340C-AF45-BD25-2AF359F1AF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CEF852-5025-554A-B738-F7108A090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64DF20-9528-0440-9638-F04313D99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AA3D96-622B-8E48-BF56-5EC1B5A8B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747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7C0F9B-E001-8B45-B4A8-B9F72D3748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A99C9F8-1475-A048-80BE-3B95EFF19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964C4C-FEC0-DD4D-97C6-4B7834473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DC84BE-31AA-9148-8412-DF4349EAC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873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AAD816-659A-BB4A-9CF3-BFD9727DB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35AE57-28AB-0F47-A75D-60DF74683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04C76F-E7E4-F342-9097-114C74AF4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776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A5F09-FAD2-DC48-A3B3-82A129487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B29160-1420-0242-B466-EDA4FBCF92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7667D2-5BA8-504D-9053-28D2CEB490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F9C8B5-B94B-8D46-95C7-87AD66036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FB930A-E0A9-AA47-A0BE-D25D8BEA9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4AF384-F944-C64E-8012-C7D848AED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413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5C5D4-1D33-F041-A0AF-4667D61180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72C058-D0ED-6249-9B30-04C4E63EEA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2E30F1-D0DC-234E-BD8F-2ACBE80E2E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1F96FF-2ED6-394D-805E-00F5CC11E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5647E4-5388-1F41-8A2E-59603DBDA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0243B9-6C9F-ED4F-9955-3BF1ABEA6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185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6E89D6-7108-9D42-B76B-A6B85E96E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C30C1A-2B22-A740-B1D8-05F708FAA3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5F8AE0-602D-4540-A0BD-39E77C85F6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6ADFE-A52B-8D4D-9923-48C24A6B889C}" type="datetimeFigureOut">
              <a:rPr lang="en-US" smtClean="0"/>
              <a:t>6/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683EA-86AD-2F44-AB0A-A586D9A555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18D994-5135-D041-9571-DA5F60E3F4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FB57E-4251-B84D-AD84-9AE275BB1E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415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A65D34F-01D8-6840-A140-C6D7906540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7640" y="121483"/>
            <a:ext cx="4455928" cy="579965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0864C96-0D72-AD46-B19A-326564A626D9}"/>
              </a:ext>
            </a:extLst>
          </p:cNvPr>
          <p:cNvSpPr/>
          <p:nvPr/>
        </p:nvSpPr>
        <p:spPr>
          <a:xfrm>
            <a:off x="3517640" y="6158005"/>
            <a:ext cx="4846320" cy="4054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1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Flowchart/overview of research study design.</a:t>
            </a:r>
          </a:p>
        </p:txBody>
      </p:sp>
    </p:spTree>
    <p:extLst>
      <p:ext uri="{BB962C8B-B14F-4D97-AF65-F5344CB8AC3E}">
        <p14:creationId xmlns:p14="http://schemas.microsoft.com/office/powerpoint/2010/main" val="13883467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B0856F9-340B-0E40-9D3B-7154F9912FB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190"/>
          <a:stretch/>
        </p:blipFill>
        <p:spPr>
          <a:xfrm>
            <a:off x="1780541" y="345846"/>
            <a:ext cx="9049991" cy="5241137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F8DE198-7ACE-CC4F-AD1C-4B3B8AE1D845}"/>
              </a:ext>
            </a:extLst>
          </p:cNvPr>
          <p:cNvSpPr/>
          <p:nvPr/>
        </p:nvSpPr>
        <p:spPr>
          <a:xfrm>
            <a:off x="7062159" y="2472906"/>
            <a:ext cx="2334884" cy="1357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0958B3C-BC25-644C-923B-FC0025EB0855}"/>
              </a:ext>
            </a:extLst>
          </p:cNvPr>
          <p:cNvSpPr/>
          <p:nvPr/>
        </p:nvSpPr>
        <p:spPr>
          <a:xfrm>
            <a:off x="4088776" y="2453040"/>
            <a:ext cx="2334884" cy="1357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56AFEF8-913C-6541-8D55-44871CE12EF6}"/>
              </a:ext>
            </a:extLst>
          </p:cNvPr>
          <p:cNvSpPr/>
          <p:nvPr/>
        </p:nvSpPr>
        <p:spPr>
          <a:xfrm>
            <a:off x="7062159" y="4804913"/>
            <a:ext cx="2334884" cy="1357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012C04E-E5EA-6F4A-98CB-B8A352A7E688}"/>
              </a:ext>
            </a:extLst>
          </p:cNvPr>
          <p:cNvSpPr/>
          <p:nvPr/>
        </p:nvSpPr>
        <p:spPr>
          <a:xfrm>
            <a:off x="4088776" y="4804913"/>
            <a:ext cx="2334884" cy="1357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B5003FC-3238-4A4D-A0F0-A38A69B36E63}"/>
              </a:ext>
            </a:extLst>
          </p:cNvPr>
          <p:cNvSpPr/>
          <p:nvPr/>
        </p:nvSpPr>
        <p:spPr>
          <a:xfrm>
            <a:off x="2011680" y="4998725"/>
            <a:ext cx="8823960" cy="15134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2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verall levels of LDHA and LDHB expression individually between clusters produced from k-means in the discovery and validation set. (A) cluster versus gene expression of LDHA in the discovery set (P = 1.54e-15). (B) cluster versus gene expression of LDHB in the discovery set (P = 6.09e-08). (C) cluster versus gene expression of LDHA in the validation set (P = 1.27e-12). (D) cluster versus gene expression of LDHB in the validation set (P = 6.35e-09)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31D5C0-BD93-B44A-ABF0-AC3717612810}"/>
              </a:ext>
            </a:extLst>
          </p:cNvPr>
          <p:cNvSpPr txBox="1"/>
          <p:nvPr/>
        </p:nvSpPr>
        <p:spPr>
          <a:xfrm>
            <a:off x="5287704" y="2408571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FF8049-DEF7-4847-9E8F-6424887539FE}"/>
              </a:ext>
            </a:extLst>
          </p:cNvPr>
          <p:cNvSpPr txBox="1"/>
          <p:nvPr/>
        </p:nvSpPr>
        <p:spPr>
          <a:xfrm>
            <a:off x="4152915" y="2414577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0DA5533-C1C8-A74B-B98C-BE48DE7E97AE}"/>
              </a:ext>
            </a:extLst>
          </p:cNvPr>
          <p:cNvSpPr txBox="1"/>
          <p:nvPr/>
        </p:nvSpPr>
        <p:spPr>
          <a:xfrm>
            <a:off x="8347134" y="2408571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B6A37CA-6404-DD45-AB92-37998E6BF9BB}"/>
              </a:ext>
            </a:extLst>
          </p:cNvPr>
          <p:cNvSpPr txBox="1"/>
          <p:nvPr/>
        </p:nvSpPr>
        <p:spPr>
          <a:xfrm>
            <a:off x="7212345" y="2414577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9C5E20-9D1E-7547-BFE2-C9E3E067EB9B}"/>
              </a:ext>
            </a:extLst>
          </p:cNvPr>
          <p:cNvSpPr txBox="1"/>
          <p:nvPr/>
        </p:nvSpPr>
        <p:spPr>
          <a:xfrm>
            <a:off x="5287704" y="4740578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6342E62-9891-2F49-AA32-7EAD89C025A2}"/>
              </a:ext>
            </a:extLst>
          </p:cNvPr>
          <p:cNvSpPr txBox="1"/>
          <p:nvPr/>
        </p:nvSpPr>
        <p:spPr>
          <a:xfrm>
            <a:off x="4152915" y="4746584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A4CFBC-E205-FE4B-9FC9-3705E5C996E3}"/>
              </a:ext>
            </a:extLst>
          </p:cNvPr>
          <p:cNvSpPr txBox="1"/>
          <p:nvPr/>
        </p:nvSpPr>
        <p:spPr>
          <a:xfrm>
            <a:off x="8347134" y="4740660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FAF03E-DA89-7940-A158-703BCAC43D45}"/>
              </a:ext>
            </a:extLst>
          </p:cNvPr>
          <p:cNvSpPr txBox="1"/>
          <p:nvPr/>
        </p:nvSpPr>
        <p:spPr>
          <a:xfrm>
            <a:off x="7212345" y="4746666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</p:spTree>
    <p:extLst>
      <p:ext uri="{BB962C8B-B14F-4D97-AF65-F5344CB8AC3E}">
        <p14:creationId xmlns:p14="http://schemas.microsoft.com/office/powerpoint/2010/main" val="1110751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E604DC8-CFA8-C247-8868-1A06D14EAE6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861"/>
          <a:stretch/>
        </p:blipFill>
        <p:spPr>
          <a:xfrm>
            <a:off x="1205865" y="446048"/>
            <a:ext cx="9780270" cy="5227651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00D3B82-9F35-BB43-9D97-F7D1171B2EBE}"/>
              </a:ext>
            </a:extLst>
          </p:cNvPr>
          <p:cNvSpPr/>
          <p:nvPr/>
        </p:nvSpPr>
        <p:spPr>
          <a:xfrm>
            <a:off x="1524000" y="5115446"/>
            <a:ext cx="9144000" cy="15134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3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mmune checkpoint expression validation set analysis between clusters. (A-F) the same six immune checkpoint genes from the discovery set examined in the validation set to show that validation set cluster2 (glycolysis-high, IDH wild-type enriched) displays consistently higher expression of (A) PDL2: P = 2.50e-28, (B) PD1: P = 1.25e-14, (C) PDL1: P = 4.56e-06, (D) IDO1: P = 5.10e-9, (E) OX40: P = 1.77e-05, and (F) CTLA4: P = 1.37e-07, respectively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4D3F63F-629E-114A-8432-B4068A8E1903}"/>
              </a:ext>
            </a:extLst>
          </p:cNvPr>
          <p:cNvSpPr/>
          <p:nvPr/>
        </p:nvSpPr>
        <p:spPr>
          <a:xfrm>
            <a:off x="2321720" y="2350554"/>
            <a:ext cx="4693443" cy="2283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D32A38E-3868-1B4E-9EA8-9405A6C5075F}"/>
              </a:ext>
            </a:extLst>
          </p:cNvPr>
          <p:cNvSpPr/>
          <p:nvPr/>
        </p:nvSpPr>
        <p:spPr>
          <a:xfrm>
            <a:off x="4360071" y="4815277"/>
            <a:ext cx="2547936" cy="2283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28F644C-169D-3549-B517-D373486FD515}"/>
              </a:ext>
            </a:extLst>
          </p:cNvPr>
          <p:cNvSpPr/>
          <p:nvPr/>
        </p:nvSpPr>
        <p:spPr>
          <a:xfrm>
            <a:off x="7427121" y="4746676"/>
            <a:ext cx="2431254" cy="2283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A7414B9-4AD5-D443-8F64-2B8A298D05D6}"/>
              </a:ext>
            </a:extLst>
          </p:cNvPr>
          <p:cNvSpPr/>
          <p:nvPr/>
        </p:nvSpPr>
        <p:spPr>
          <a:xfrm>
            <a:off x="1876428" y="4746676"/>
            <a:ext cx="2547936" cy="22833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52CA42A-B0B5-3D44-9F9C-BA67CFD04D91}"/>
              </a:ext>
            </a:extLst>
          </p:cNvPr>
          <p:cNvSpPr/>
          <p:nvPr/>
        </p:nvSpPr>
        <p:spPr>
          <a:xfrm>
            <a:off x="7522154" y="2422613"/>
            <a:ext cx="2431254" cy="22833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D234CB6-B5D7-1748-9389-489004BD224D}"/>
              </a:ext>
            </a:extLst>
          </p:cNvPr>
          <p:cNvSpPr txBox="1"/>
          <p:nvPr/>
        </p:nvSpPr>
        <p:spPr>
          <a:xfrm>
            <a:off x="3215064" y="2310108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D34DD3-3966-EC4D-B229-F5F6EA9AEEAC}"/>
              </a:ext>
            </a:extLst>
          </p:cNvPr>
          <p:cNvSpPr txBox="1"/>
          <p:nvPr/>
        </p:nvSpPr>
        <p:spPr>
          <a:xfrm>
            <a:off x="2080275" y="2316114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1FD3F0-17E5-814B-8FDE-3281257C9F69}"/>
              </a:ext>
            </a:extLst>
          </p:cNvPr>
          <p:cNvSpPr txBox="1"/>
          <p:nvPr/>
        </p:nvSpPr>
        <p:spPr>
          <a:xfrm>
            <a:off x="5993995" y="2310108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F3E80F2-9FE2-C64F-8625-A78615166D68}"/>
              </a:ext>
            </a:extLst>
          </p:cNvPr>
          <p:cNvSpPr txBox="1"/>
          <p:nvPr/>
        </p:nvSpPr>
        <p:spPr>
          <a:xfrm>
            <a:off x="4859206" y="2316114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4BA822-A194-6A48-99C5-A6D4597D2D69}"/>
              </a:ext>
            </a:extLst>
          </p:cNvPr>
          <p:cNvSpPr txBox="1"/>
          <p:nvPr/>
        </p:nvSpPr>
        <p:spPr>
          <a:xfrm>
            <a:off x="8823957" y="2350554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0CF9C16-3FA6-CA41-9924-BF195C023D63}"/>
              </a:ext>
            </a:extLst>
          </p:cNvPr>
          <p:cNvSpPr txBox="1"/>
          <p:nvPr/>
        </p:nvSpPr>
        <p:spPr>
          <a:xfrm>
            <a:off x="7689168" y="2356560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5A231E8-683F-7444-A903-35B0BDAF8223}"/>
              </a:ext>
            </a:extLst>
          </p:cNvPr>
          <p:cNvSpPr txBox="1"/>
          <p:nvPr/>
        </p:nvSpPr>
        <p:spPr>
          <a:xfrm>
            <a:off x="3235950" y="4715439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CEEB405-3AB0-CC40-9D0D-8FC7637151E2}"/>
              </a:ext>
            </a:extLst>
          </p:cNvPr>
          <p:cNvSpPr txBox="1"/>
          <p:nvPr/>
        </p:nvSpPr>
        <p:spPr>
          <a:xfrm>
            <a:off x="2101161" y="4721445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81AE203-3D32-C347-997D-95DDAA336DF8}"/>
              </a:ext>
            </a:extLst>
          </p:cNvPr>
          <p:cNvSpPr txBox="1"/>
          <p:nvPr/>
        </p:nvSpPr>
        <p:spPr>
          <a:xfrm>
            <a:off x="5993995" y="4760689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72BAFA2-3EB8-D340-9FE7-84BE26C7DE2F}"/>
              </a:ext>
            </a:extLst>
          </p:cNvPr>
          <p:cNvSpPr txBox="1"/>
          <p:nvPr/>
        </p:nvSpPr>
        <p:spPr>
          <a:xfrm>
            <a:off x="4859206" y="4766695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A05385C-8583-0F42-BD3C-609423102B52}"/>
              </a:ext>
            </a:extLst>
          </p:cNvPr>
          <p:cNvSpPr txBox="1"/>
          <p:nvPr/>
        </p:nvSpPr>
        <p:spPr>
          <a:xfrm>
            <a:off x="8823957" y="4713120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low cluste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F1F9467-7EFF-1041-8686-2B66146EC91E}"/>
              </a:ext>
            </a:extLst>
          </p:cNvPr>
          <p:cNvSpPr txBox="1"/>
          <p:nvPr/>
        </p:nvSpPr>
        <p:spPr>
          <a:xfrm>
            <a:off x="7689168" y="4719126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Glycolysis-high cluster</a:t>
            </a:r>
          </a:p>
        </p:txBody>
      </p:sp>
    </p:spTree>
    <p:extLst>
      <p:ext uri="{BB962C8B-B14F-4D97-AF65-F5344CB8AC3E}">
        <p14:creationId xmlns:p14="http://schemas.microsoft.com/office/powerpoint/2010/main" val="13979014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2F1EB90-21E5-F14F-A569-2F52CD25C6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1922" y="0"/>
            <a:ext cx="9368155" cy="588497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32BDEA87-61C2-0841-BC74-EA92B60158ED}"/>
              </a:ext>
            </a:extLst>
          </p:cNvPr>
          <p:cNvSpPr/>
          <p:nvPr/>
        </p:nvSpPr>
        <p:spPr>
          <a:xfrm>
            <a:off x="1859280" y="5486564"/>
            <a:ext cx="9144000" cy="11440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4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moter methylation analysis of the remaining four immune checkpoint genes (IDO1, PD1 [PDCD1], OX40 [TNFRSF4], CTLA4) that were also elevated in the glycolytic IDH wild-type enriched cluster in the discovery set. (A) IDO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28, p = 6.31e-6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(B) PD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31, p = 5.00e-7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(C) OX40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27, p = 1.45e-5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(D) CTLA4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12, p = 0.06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C1D183E-5A8F-AF43-A6E7-17D42D5C0654}"/>
              </a:ext>
            </a:extLst>
          </p:cNvPr>
          <p:cNvSpPr/>
          <p:nvPr/>
        </p:nvSpPr>
        <p:spPr>
          <a:xfrm>
            <a:off x="1411922" y="211873"/>
            <a:ext cx="1409337" cy="3010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B119AB1-87D5-AE49-B6A1-01B7D9179BA8}"/>
              </a:ext>
            </a:extLst>
          </p:cNvPr>
          <p:cNvSpPr/>
          <p:nvPr/>
        </p:nvSpPr>
        <p:spPr>
          <a:xfrm>
            <a:off x="4353791" y="394855"/>
            <a:ext cx="1631373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F6F5244-48A0-D840-ADD4-7DC694230D42}"/>
              </a:ext>
            </a:extLst>
          </p:cNvPr>
          <p:cNvSpPr/>
          <p:nvPr/>
        </p:nvSpPr>
        <p:spPr>
          <a:xfrm>
            <a:off x="7517696" y="276754"/>
            <a:ext cx="1813340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D23C9D2-51B9-A947-998C-152478A459BD}"/>
              </a:ext>
            </a:extLst>
          </p:cNvPr>
          <p:cNvSpPr/>
          <p:nvPr/>
        </p:nvSpPr>
        <p:spPr>
          <a:xfrm>
            <a:off x="4350392" y="2791228"/>
            <a:ext cx="1991909" cy="1766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EE33742-F48D-9543-9BA7-089CE3DEF6FF}"/>
              </a:ext>
            </a:extLst>
          </p:cNvPr>
          <p:cNvSpPr/>
          <p:nvPr/>
        </p:nvSpPr>
        <p:spPr>
          <a:xfrm>
            <a:off x="7517696" y="2941216"/>
            <a:ext cx="1813340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C024DF-3121-D54B-B8D0-15B97E349FD1}"/>
              </a:ext>
            </a:extLst>
          </p:cNvPr>
          <p:cNvSpPr txBox="1"/>
          <p:nvPr/>
        </p:nvSpPr>
        <p:spPr>
          <a:xfrm>
            <a:off x="3907019" y="340382"/>
            <a:ext cx="24352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IDO1 promoter methylation vs IDO1 expression (r = - 0.28, p = 6.31e-6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6A225F-B765-334B-9660-EDE6ECB09E1D}"/>
              </a:ext>
            </a:extLst>
          </p:cNvPr>
          <p:cNvSpPr txBox="1"/>
          <p:nvPr/>
        </p:nvSpPr>
        <p:spPr>
          <a:xfrm>
            <a:off x="7181077" y="328290"/>
            <a:ext cx="23358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PD1 promoter methylation vs PD1 expression (r = - 0.31, p = 5.00e-7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6A69B0-8D4F-4E45-944C-F13A150741D9}"/>
              </a:ext>
            </a:extLst>
          </p:cNvPr>
          <p:cNvSpPr txBox="1"/>
          <p:nvPr/>
        </p:nvSpPr>
        <p:spPr>
          <a:xfrm>
            <a:off x="4012293" y="2765460"/>
            <a:ext cx="26276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TNFRSF4 promoter methylation vs TNFRSF4 expression (r = - 0.27, p = 1.45e-5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D081E8-33D5-C848-B6B5-21BBCCA1183B}"/>
              </a:ext>
            </a:extLst>
          </p:cNvPr>
          <p:cNvSpPr txBox="1"/>
          <p:nvPr/>
        </p:nvSpPr>
        <p:spPr>
          <a:xfrm>
            <a:off x="7317900" y="2755537"/>
            <a:ext cx="23871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CTLA4  promoter methylation vs CTLA4 expression (r = - 0.12, p = 0.06)</a:t>
            </a:r>
          </a:p>
        </p:txBody>
      </p:sp>
    </p:spTree>
    <p:extLst>
      <p:ext uri="{BB962C8B-B14F-4D97-AF65-F5344CB8AC3E}">
        <p14:creationId xmlns:p14="http://schemas.microsoft.com/office/powerpoint/2010/main" val="20181330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FE61591-D80F-8B49-8F9E-0D751ADD64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9169" y="0"/>
            <a:ext cx="8813661" cy="539496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3B6A12B4-7E68-464E-8FD1-8C86458851FE}"/>
              </a:ext>
            </a:extLst>
          </p:cNvPr>
          <p:cNvSpPr/>
          <p:nvPr/>
        </p:nvSpPr>
        <p:spPr>
          <a:xfrm>
            <a:off x="1799589" y="5166524"/>
            <a:ext cx="9433560" cy="11440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5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moter methylation analysis of the remaining four immune checkpoint genes (IDO1, PD1 [PDCD1], OX40 [TNFRSF4], CTLA4) that were also elevated in the glycolytic IDH wild-type enriched cluster in the validation set. (A) IDO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34, p = 2.69e-8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(B) PD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30, p = 1.35e-6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(C) OX40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36, p = 4.80e-9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(D) CTLA4 =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 0.02, p = 0.72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5BF5385-DAFC-5B41-8568-C645AAD19021}"/>
              </a:ext>
            </a:extLst>
          </p:cNvPr>
          <p:cNvSpPr/>
          <p:nvPr/>
        </p:nvSpPr>
        <p:spPr>
          <a:xfrm>
            <a:off x="1902575" y="246297"/>
            <a:ext cx="1409337" cy="3010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D613DCC-E909-4544-98B7-D800B8D789B9}"/>
              </a:ext>
            </a:extLst>
          </p:cNvPr>
          <p:cNvSpPr/>
          <p:nvPr/>
        </p:nvSpPr>
        <p:spPr>
          <a:xfrm>
            <a:off x="4674303" y="396838"/>
            <a:ext cx="1631373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87D9F91-AD37-D849-B605-ED8191F95CAD}"/>
              </a:ext>
            </a:extLst>
          </p:cNvPr>
          <p:cNvSpPr/>
          <p:nvPr/>
        </p:nvSpPr>
        <p:spPr>
          <a:xfrm>
            <a:off x="7248717" y="337787"/>
            <a:ext cx="1631373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4A73DC2-382B-E749-829B-CC47FDFEBDD1}"/>
              </a:ext>
            </a:extLst>
          </p:cNvPr>
          <p:cNvSpPr/>
          <p:nvPr/>
        </p:nvSpPr>
        <p:spPr>
          <a:xfrm>
            <a:off x="4745004" y="2803794"/>
            <a:ext cx="1631373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B6DC24C-703F-F347-B19D-E2FA8CCDEE0E}"/>
              </a:ext>
            </a:extLst>
          </p:cNvPr>
          <p:cNvSpPr/>
          <p:nvPr/>
        </p:nvSpPr>
        <p:spPr>
          <a:xfrm>
            <a:off x="7516483" y="2809686"/>
            <a:ext cx="1631373" cy="1181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A674FBC-17ED-8941-A763-24F1905EDCCC}"/>
              </a:ext>
            </a:extLst>
          </p:cNvPr>
          <p:cNvSpPr txBox="1"/>
          <p:nvPr/>
        </p:nvSpPr>
        <p:spPr>
          <a:xfrm>
            <a:off x="4272348" y="271222"/>
            <a:ext cx="2396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IDO1 promoter methylation vs IDO1 expression (r = - 0.34, p = 2.69e-8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5F3CAC-6921-8A40-9742-3B2F00581838}"/>
              </a:ext>
            </a:extLst>
          </p:cNvPr>
          <p:cNvSpPr txBox="1"/>
          <p:nvPr/>
        </p:nvSpPr>
        <p:spPr>
          <a:xfrm>
            <a:off x="7170219" y="2748398"/>
            <a:ext cx="23695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CTLA4 promoter methylation vs CTLA4 expression (r = - 0.02, p = 0.7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B35EFD4-BAF0-BF41-8FAE-2BBE27BD34FC}"/>
              </a:ext>
            </a:extLst>
          </p:cNvPr>
          <p:cNvSpPr txBox="1"/>
          <p:nvPr/>
        </p:nvSpPr>
        <p:spPr>
          <a:xfrm>
            <a:off x="4246869" y="2748398"/>
            <a:ext cx="26276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TNFRSF4 promoter methylation vs TNFRSF4 expression (r = - 0.36, p = 4.80e-9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FCDD02-19FD-954B-A04B-137DABA3EC42}"/>
              </a:ext>
            </a:extLst>
          </p:cNvPr>
          <p:cNvSpPr txBox="1"/>
          <p:nvPr/>
        </p:nvSpPr>
        <p:spPr>
          <a:xfrm>
            <a:off x="7036726" y="263317"/>
            <a:ext cx="23230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/>
              <a:t>PD1 promoter methylation vs PD! expression (r = - 0.30, p = 1.35e-6)</a:t>
            </a:r>
          </a:p>
        </p:txBody>
      </p:sp>
    </p:spTree>
    <p:extLst>
      <p:ext uri="{BB962C8B-B14F-4D97-AF65-F5344CB8AC3E}">
        <p14:creationId xmlns:p14="http://schemas.microsoft.com/office/powerpoint/2010/main" val="33740444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243B1B3-0752-7B4C-9E9D-EBE9511829C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492"/>
          <a:stretch/>
        </p:blipFill>
        <p:spPr>
          <a:xfrm>
            <a:off x="488950" y="479684"/>
            <a:ext cx="11090868" cy="409231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DE5C7C2-4B66-A746-B88C-AED3DE995A1D}"/>
              </a:ext>
            </a:extLst>
          </p:cNvPr>
          <p:cNvSpPr/>
          <p:nvPr/>
        </p:nvSpPr>
        <p:spPr>
          <a:xfrm>
            <a:off x="2042160" y="4572000"/>
            <a:ext cx="8655050" cy="11440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6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H3K4me3 enrichment results from an IDH-mutant knock-in immortalized primary human astrocyte cell line. (A-C) A decrease in promoter H3K3me4 (marker of active transcription) was observed in (A) LDHA, (B) PDL2, and (C) PDL1 upon induction of the IDH mutant.</a:t>
            </a:r>
          </a:p>
        </p:txBody>
      </p:sp>
    </p:spTree>
    <p:extLst>
      <p:ext uri="{BB962C8B-B14F-4D97-AF65-F5344CB8AC3E}">
        <p14:creationId xmlns:p14="http://schemas.microsoft.com/office/powerpoint/2010/main" val="21602821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A72B8B6-FCEA-684E-A54D-020495AC80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8817942"/>
              </p:ext>
            </p:extLst>
          </p:nvPr>
        </p:nvGraphicFramePr>
        <p:xfrm>
          <a:off x="502790" y="1417417"/>
          <a:ext cx="10905075" cy="3313057"/>
        </p:xfrm>
        <a:graphic>
          <a:graphicData uri="http://schemas.openxmlformats.org/drawingml/2006/table">
            <a:tbl>
              <a:tblPr firstRow="1" bandRow="1"/>
              <a:tblGrid>
                <a:gridCol w="886763">
                  <a:extLst>
                    <a:ext uri="{9D8B030D-6E8A-4147-A177-3AD203B41FA5}">
                      <a16:colId xmlns:a16="http://schemas.microsoft.com/office/drawing/2014/main" val="3302173612"/>
                    </a:ext>
                  </a:extLst>
                </a:gridCol>
                <a:gridCol w="950754">
                  <a:extLst>
                    <a:ext uri="{9D8B030D-6E8A-4147-A177-3AD203B41FA5}">
                      <a16:colId xmlns:a16="http://schemas.microsoft.com/office/drawing/2014/main" val="1560981840"/>
                    </a:ext>
                  </a:extLst>
                </a:gridCol>
                <a:gridCol w="901695">
                  <a:extLst>
                    <a:ext uri="{9D8B030D-6E8A-4147-A177-3AD203B41FA5}">
                      <a16:colId xmlns:a16="http://schemas.microsoft.com/office/drawing/2014/main" val="1260683027"/>
                    </a:ext>
                  </a:extLst>
                </a:gridCol>
                <a:gridCol w="950754">
                  <a:extLst>
                    <a:ext uri="{9D8B030D-6E8A-4147-A177-3AD203B41FA5}">
                      <a16:colId xmlns:a16="http://schemas.microsoft.com/office/drawing/2014/main" val="2438150231"/>
                    </a:ext>
                  </a:extLst>
                </a:gridCol>
                <a:gridCol w="901695">
                  <a:extLst>
                    <a:ext uri="{9D8B030D-6E8A-4147-A177-3AD203B41FA5}">
                      <a16:colId xmlns:a16="http://schemas.microsoft.com/office/drawing/2014/main" val="388241698"/>
                    </a:ext>
                  </a:extLst>
                </a:gridCol>
                <a:gridCol w="624399">
                  <a:extLst>
                    <a:ext uri="{9D8B030D-6E8A-4147-A177-3AD203B41FA5}">
                      <a16:colId xmlns:a16="http://schemas.microsoft.com/office/drawing/2014/main" val="238884401"/>
                    </a:ext>
                  </a:extLst>
                </a:gridCol>
                <a:gridCol w="679859">
                  <a:extLst>
                    <a:ext uri="{9D8B030D-6E8A-4147-A177-3AD203B41FA5}">
                      <a16:colId xmlns:a16="http://schemas.microsoft.com/office/drawing/2014/main" val="3599331065"/>
                    </a:ext>
                  </a:extLst>
                </a:gridCol>
                <a:gridCol w="950754">
                  <a:extLst>
                    <a:ext uri="{9D8B030D-6E8A-4147-A177-3AD203B41FA5}">
                      <a16:colId xmlns:a16="http://schemas.microsoft.com/office/drawing/2014/main" val="3084814338"/>
                    </a:ext>
                  </a:extLst>
                </a:gridCol>
                <a:gridCol w="901695">
                  <a:extLst>
                    <a:ext uri="{9D8B030D-6E8A-4147-A177-3AD203B41FA5}">
                      <a16:colId xmlns:a16="http://schemas.microsoft.com/office/drawing/2014/main" val="328537364"/>
                    </a:ext>
                  </a:extLst>
                </a:gridCol>
                <a:gridCol w="950754">
                  <a:extLst>
                    <a:ext uri="{9D8B030D-6E8A-4147-A177-3AD203B41FA5}">
                      <a16:colId xmlns:a16="http://schemas.microsoft.com/office/drawing/2014/main" val="353321899"/>
                    </a:ext>
                  </a:extLst>
                </a:gridCol>
                <a:gridCol w="901695">
                  <a:extLst>
                    <a:ext uri="{9D8B030D-6E8A-4147-A177-3AD203B41FA5}">
                      <a16:colId xmlns:a16="http://schemas.microsoft.com/office/drawing/2014/main" val="3069989127"/>
                    </a:ext>
                  </a:extLst>
                </a:gridCol>
                <a:gridCol w="624399">
                  <a:extLst>
                    <a:ext uri="{9D8B030D-6E8A-4147-A177-3AD203B41FA5}">
                      <a16:colId xmlns:a16="http://schemas.microsoft.com/office/drawing/2014/main" val="1979595778"/>
                    </a:ext>
                  </a:extLst>
                </a:gridCol>
                <a:gridCol w="679859">
                  <a:extLst>
                    <a:ext uri="{9D8B030D-6E8A-4147-A177-3AD203B41FA5}">
                      <a16:colId xmlns:a16="http://schemas.microsoft.com/office/drawing/2014/main" val="2949936451"/>
                    </a:ext>
                  </a:extLst>
                </a:gridCol>
              </a:tblGrid>
              <a:tr h="276611">
                <a:tc rowSpan="2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scovery Set (IDH-mutant-1p/19q-non-codeletion only)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high*: (n = 10)/11, Glycolysis-low: (n = 112)/196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Enriched for 1p/19q non-codeletion (P = 0.027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idation Set (IDH-mutant-1p/19q-non-codeletion only)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high*: (n = 35)/39, Glycolysis-low: (n = 91)/ 169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Enriched for 1p/19q non-codeletion (P &lt; 0.0001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6759115"/>
                  </a:ext>
                </a:extLst>
              </a:tr>
              <a:tr h="670422"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high cluster (me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low cluster (me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high cluster (medi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low cluster (medi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-statistic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high cluster (me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low cluster (me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high cluster (medi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colysis-low cluster (median)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-statistic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8934936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HA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6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2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68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7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5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62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1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54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4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0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95348777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DHB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3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7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0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16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6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0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98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25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07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21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9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33025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2*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2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1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22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9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94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76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0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0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0e-1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8451487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1*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6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8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8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8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6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3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9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5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3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94231757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-L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46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9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1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2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0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6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3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8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7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4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2686953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O1*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1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6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7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1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8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4226807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RSF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2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0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1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5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6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6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1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4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0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6993919"/>
                  </a:ext>
                </a:extLst>
              </a:tr>
              <a:tr h="2608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LA4*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9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68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67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8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0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2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24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19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75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3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1</a:t>
                      </a:r>
                    </a:p>
                  </a:txBody>
                  <a:tcPr marL="6963" marR="6963" marT="6963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6400121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96C6A6A8-F0E8-E94C-8098-7A2AB46857C5}"/>
              </a:ext>
            </a:extLst>
          </p:cNvPr>
          <p:cNvSpPr/>
          <p:nvPr/>
        </p:nvSpPr>
        <p:spPr>
          <a:xfrm>
            <a:off x="1343940" y="4882780"/>
            <a:ext cx="9941859" cy="13193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Table 1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analysis of LDHA, LDHB, and immune checkpoint genes in IDH-mutant 1p/19q non-codeletion samples. Analysis in the discovery set (left half of table) and the validation set (right half of table) surfaced PD-L2, PD1 (PDCD1), IDO1, and CTLA4 as elevated in the glycolysis high cluster (* = P &lt; 0.05).</a:t>
            </a:r>
          </a:p>
        </p:txBody>
      </p:sp>
    </p:spTree>
    <p:extLst>
      <p:ext uri="{BB962C8B-B14F-4D97-AF65-F5344CB8AC3E}">
        <p14:creationId xmlns:p14="http://schemas.microsoft.com/office/powerpoint/2010/main" val="26819517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8C7230-A2D8-1A44-8CBD-8D65CF2625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665"/>
          <a:stretch/>
        </p:blipFill>
        <p:spPr>
          <a:xfrm>
            <a:off x="1766570" y="745957"/>
            <a:ext cx="8663372" cy="471300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860C4B3C-C5F5-7140-947B-91EF84AA4F63}"/>
              </a:ext>
            </a:extLst>
          </p:cNvPr>
          <p:cNvSpPr/>
          <p:nvPr/>
        </p:nvSpPr>
        <p:spPr>
          <a:xfrm>
            <a:off x="1524000" y="5629082"/>
            <a:ext cx="9144000" cy="7747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Table 2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GO biological process site enrichment following induction of a knock-in IDH1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132H/WT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llele in HCT116 cells. GO biological processes in left column refer to processes with gene enrichment in methylation following induction of IDH1 mutant expression.</a:t>
            </a:r>
          </a:p>
        </p:txBody>
      </p:sp>
    </p:spTree>
    <p:extLst>
      <p:ext uri="{BB962C8B-B14F-4D97-AF65-F5344CB8AC3E}">
        <p14:creationId xmlns:p14="http://schemas.microsoft.com/office/powerpoint/2010/main" val="790410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29</TotalTime>
  <Words>978</Words>
  <Application>Microsoft Macintosh PowerPoint</Application>
  <PresentationFormat>Widescreen</PresentationFormat>
  <Paragraphs>161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vechian, Kevin</dc:creator>
  <cp:lastModifiedBy>Givechian, Kevin</cp:lastModifiedBy>
  <cp:revision>12</cp:revision>
  <dcterms:created xsi:type="dcterms:W3CDTF">2020-06-05T21:22:19Z</dcterms:created>
  <dcterms:modified xsi:type="dcterms:W3CDTF">2020-06-16T21:12:10Z</dcterms:modified>
</cp:coreProperties>
</file>